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71600" y="1142640"/>
            <a:ext cx="41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A6A94FF-0937-424E-92CA-7E247343485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Only men manifest the ‘prodromal’ pattern…. High CA1 CBV, High Glx, no difference in CA1 volum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D4B9E16-086E-4F2B-BE47-9EB036C7D59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CED19-B333-490B-9886-FC24077EA9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A5AF85-BFBC-4481-9989-C0758AB965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E74482-2CA7-44A9-AAAE-780428AE56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7D2CA4-EC65-4B3F-A6E6-9AE6945D65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77AD0-C11F-4BD4-8DBF-FA564C61E5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487C6-996D-4F84-B9F4-459F69DC24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7577E4-AF25-48C8-91B1-5C134A49B4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D4C088-AB26-43FD-BAD0-FC0AEAFED1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96F048-5EC2-4582-B1E6-FB1C73FDF7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C1F71-64E1-4323-AEED-3F74182F87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AACC6-F507-41BE-8158-DC3CACBCB7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C280A1-D5D8-4204-B555-AAE78534E3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8837126-0A4E-4917-BF80-5A5E9B7F2EB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1"/>
          <p:cNvGrpSpPr/>
          <p:nvPr/>
        </p:nvGrpSpPr>
        <p:grpSpPr>
          <a:xfrm>
            <a:off x="1604880" y="880920"/>
            <a:ext cx="5278680" cy="2473920"/>
            <a:chOff x="1604880" y="880920"/>
            <a:chExt cx="5278680" cy="2473920"/>
          </a:xfrm>
        </p:grpSpPr>
        <p:sp>
          <p:nvSpPr>
            <p:cNvPr id="49" name="Straight Connector 23"/>
            <p:cNvSpPr/>
            <p:nvPr/>
          </p:nvSpPr>
          <p:spPr>
            <a:xfrm>
              <a:off x="1650600" y="880920"/>
              <a:ext cx="0" cy="1942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Straight Connector 24"/>
            <p:cNvSpPr/>
            <p:nvPr/>
          </p:nvSpPr>
          <p:spPr>
            <a:xfrm flipH="1">
              <a:off x="1650600" y="2823120"/>
              <a:ext cx="52329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Freeform 25"/>
            <p:cNvSpPr/>
            <p:nvPr/>
          </p:nvSpPr>
          <p:spPr>
            <a:xfrm>
              <a:off x="1866960" y="1145880"/>
              <a:ext cx="2502360" cy="1438560"/>
            </a:xfrm>
            <a:custGeom>
              <a:avLst/>
              <a:gdLst/>
              <a:ahLst/>
              <a:rect l="l" t="t" r="r" b="b"/>
              <a:pathLst>
                <a:path w="4351395" h="1438370">
                  <a:moveTo>
                    <a:pt x="0" y="1438370"/>
                  </a:moveTo>
                  <a:lnTo>
                    <a:pt x="1083180" y="878153"/>
                  </a:lnTo>
                  <a:cubicBezTo>
                    <a:pt x="1512717" y="660291"/>
                    <a:pt x="2032519" y="277474"/>
                    <a:pt x="2577221" y="131195"/>
                  </a:cubicBezTo>
                  <a:cubicBezTo>
                    <a:pt x="3121923" y="-15084"/>
                    <a:pt x="4351395" y="478"/>
                    <a:pt x="4351395" y="478"/>
                  </a:cubicBezTo>
                  <a:lnTo>
                    <a:pt x="4351395" y="478"/>
                  </a:lnTo>
                </a:path>
              </a:pathLst>
            </a:cu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Freeform 26"/>
            <p:cNvSpPr/>
            <p:nvPr/>
          </p:nvSpPr>
          <p:spPr>
            <a:xfrm>
              <a:off x="2665080" y="1060920"/>
              <a:ext cx="2697480" cy="1523520"/>
            </a:xfrm>
            <a:custGeom>
              <a:avLst/>
              <a:gdLst/>
              <a:ahLst/>
              <a:rect l="l" t="t" r="r" b="b"/>
              <a:pathLst>
                <a:path w="4351395" h="1438370">
                  <a:moveTo>
                    <a:pt x="0" y="1438370"/>
                  </a:moveTo>
                  <a:lnTo>
                    <a:pt x="1083180" y="878153"/>
                  </a:lnTo>
                  <a:cubicBezTo>
                    <a:pt x="1512717" y="660291"/>
                    <a:pt x="2032519" y="277474"/>
                    <a:pt x="2577221" y="131195"/>
                  </a:cubicBezTo>
                  <a:cubicBezTo>
                    <a:pt x="3121923" y="-15084"/>
                    <a:pt x="4351395" y="478"/>
                    <a:pt x="4351395" y="478"/>
                  </a:cubicBezTo>
                  <a:lnTo>
                    <a:pt x="4351395" y="478"/>
                  </a:lnTo>
                </a:path>
              </a:pathLst>
            </a:custGeom>
            <a:noFill/>
            <a:ln w="1260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Freeform 30"/>
            <p:cNvSpPr/>
            <p:nvPr/>
          </p:nvSpPr>
          <p:spPr>
            <a:xfrm>
              <a:off x="4259880" y="954000"/>
              <a:ext cx="2462400" cy="1630440"/>
            </a:xfrm>
            <a:custGeom>
              <a:avLst/>
              <a:gdLst/>
              <a:ahLst/>
              <a:rect l="l" t="t" r="r" b="b"/>
              <a:pathLst>
                <a:path w="4351395" h="1438370">
                  <a:moveTo>
                    <a:pt x="0" y="1438370"/>
                  </a:moveTo>
                  <a:lnTo>
                    <a:pt x="1083180" y="878153"/>
                  </a:lnTo>
                  <a:cubicBezTo>
                    <a:pt x="1512717" y="660291"/>
                    <a:pt x="2032519" y="277474"/>
                    <a:pt x="2577221" y="131195"/>
                  </a:cubicBezTo>
                  <a:cubicBezTo>
                    <a:pt x="3121923" y="-15084"/>
                    <a:pt x="4351395" y="478"/>
                    <a:pt x="4351395" y="478"/>
                  </a:cubicBezTo>
                  <a:lnTo>
                    <a:pt x="4351395" y="478"/>
                  </a:lnTo>
                </a:path>
              </a:pathLst>
            </a:custGeom>
            <a:noFill/>
            <a:ln w="12600">
              <a:solidFill>
                <a:srgbClr val="4472c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Straight Connector 31"/>
            <p:cNvSpPr/>
            <p:nvPr/>
          </p:nvSpPr>
          <p:spPr>
            <a:xfrm>
              <a:off x="3411720" y="880920"/>
              <a:ext cx="0" cy="1942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Straight Connector 36"/>
            <p:cNvSpPr/>
            <p:nvPr/>
          </p:nvSpPr>
          <p:spPr>
            <a:xfrm>
              <a:off x="4259880" y="1145880"/>
              <a:ext cx="246708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Straight Connector 37"/>
            <p:cNvSpPr/>
            <p:nvPr/>
          </p:nvSpPr>
          <p:spPr>
            <a:xfrm flipV="1">
              <a:off x="5306040" y="1044000"/>
              <a:ext cx="1420560" cy="15480"/>
            </a:xfrm>
            <a:prstGeom prst="line">
              <a:avLst/>
            </a:prstGeom>
            <a:ln w="1260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38"/>
            <p:cNvSpPr/>
            <p:nvPr/>
          </p:nvSpPr>
          <p:spPr>
            <a:xfrm>
              <a:off x="1604880" y="2834640"/>
              <a:ext cx="18414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Attenuated Psychosis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Early Prodromal Stag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41"/>
            <p:cNvSpPr/>
            <p:nvPr/>
          </p:nvSpPr>
          <p:spPr>
            <a:xfrm rot="19113000">
              <a:off x="2124360" y="1704960"/>
              <a:ext cx="1422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ff0000"/>
                  </a:solidFill>
                  <a:latin typeface="Calibri"/>
                </a:rPr>
                <a:t>Glutamat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42"/>
            <p:cNvSpPr/>
            <p:nvPr/>
          </p:nvSpPr>
          <p:spPr>
            <a:xfrm rot="19113000">
              <a:off x="3234240" y="1484640"/>
              <a:ext cx="1422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8000"/>
                  </a:solidFill>
                  <a:latin typeface="Calibri"/>
                </a:rPr>
                <a:t>Metabolism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43"/>
            <p:cNvSpPr/>
            <p:nvPr/>
          </p:nvSpPr>
          <p:spPr>
            <a:xfrm rot="18672600">
              <a:off x="4385880" y="1704600"/>
              <a:ext cx="1422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3366ff"/>
                  </a:solidFill>
                  <a:latin typeface="Calibri"/>
                </a:rPr>
                <a:t>Atrophy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61" name="Straight Arrow Connector 6"/>
          <p:cNvCxnSpPr/>
          <p:nvPr/>
        </p:nvCxnSpPr>
        <p:spPr>
          <a:xfrm>
            <a:off x="2090880" y="2487240"/>
            <a:ext cx="575280" cy="1080"/>
          </a:xfrm>
          <a:prstGeom prst="straightConnector1">
            <a:avLst/>
          </a:prstGeom>
          <a:ln w="1260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62" name="Straight Arrow Connector 44"/>
          <p:cNvCxnSpPr/>
          <p:nvPr/>
        </p:nvCxnSpPr>
        <p:spPr>
          <a:xfrm>
            <a:off x="2242800" y="2344320"/>
            <a:ext cx="2127960" cy="1080"/>
          </a:xfrm>
          <a:prstGeom prst="straightConnector1">
            <a:avLst/>
          </a:prstGeom>
          <a:ln w="1260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63" name="TextBox 1"/>
          <p:cNvSpPr/>
          <p:nvPr/>
        </p:nvSpPr>
        <p:spPr>
          <a:xfrm>
            <a:off x="4491000" y="744480"/>
            <a:ext cx="1022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8000"/>
                </a:solidFill>
                <a:latin typeface="Calibri"/>
              </a:rPr>
              <a:t>CBV-fMR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19"/>
          <p:cNvSpPr/>
          <p:nvPr/>
        </p:nvSpPr>
        <p:spPr>
          <a:xfrm>
            <a:off x="5919840" y="635040"/>
            <a:ext cx="1022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3366ff"/>
                </a:solidFill>
                <a:latin typeface="Calibri"/>
              </a:rPr>
              <a:t>sMR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Straight Connector 22"/>
          <p:cNvSpPr/>
          <p:nvPr/>
        </p:nvSpPr>
        <p:spPr>
          <a:xfrm>
            <a:off x="5110200" y="852480"/>
            <a:ext cx="0" cy="1941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7"/>
          <p:cNvSpPr/>
          <p:nvPr/>
        </p:nvSpPr>
        <p:spPr>
          <a:xfrm>
            <a:off x="3375000" y="2851200"/>
            <a:ext cx="18399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Attenuated Psychosi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ate Prodromal Stag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8"/>
          <p:cNvSpPr/>
          <p:nvPr/>
        </p:nvSpPr>
        <p:spPr>
          <a:xfrm>
            <a:off x="4971960" y="2851200"/>
            <a:ext cx="1841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Psychosis Stag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itle 3"/>
          <p:cNvSpPr/>
          <p:nvPr/>
        </p:nvSpPr>
        <p:spPr>
          <a:xfrm>
            <a:off x="204840" y="171360"/>
            <a:ext cx="1568520" cy="39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22" presetSubtype="8" repeatCount="3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left)" transition="in">
                                      <p:cBhvr additive="repl">
                                        <p:cTn id="7" dur="500"/>
                                        <p:tgtEl>
                                          <p:spTgt spid="6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1500"/>
                            </p:stCondLst>
                            <p:childTnLst>
                              <p:par>
                                <p:cTn id="9" nodeType="afterEffect" fill="hold" presetClass="entr" presetID="2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left)" transition="in">
                                      <p:cBhvr additive="repl">
                                        <p:cTn id="11" dur="10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6-29T18:13:48Z</dcterms:created>
  <dc:creator>Delgado, Iris (NYSPI)</dc:creator>
  <dc:description/>
  <dc:language>en-US</dc:language>
  <cp:lastModifiedBy>Nishanth Kumar KH.</cp:lastModifiedBy>
  <dcterms:modified xsi:type="dcterms:W3CDTF">2017-12-28T12:24:26Z</dcterms:modified>
  <cp:revision>2</cp:revision>
  <dc:subject/>
  <dc:title>PowerPoint Presentation</dc:title>
</cp:coreProperties>
</file>